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2" d="100"/>
          <a:sy n="102" d="100"/>
        </p:scale>
        <p:origin x="72" y="1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81817-5A37-4569-9C30-95678D619DC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54CD8-D8EF-46AA-9D8B-8363D6BAE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885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81817-5A37-4569-9C30-95678D619DC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54CD8-D8EF-46AA-9D8B-8363D6BAE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116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81817-5A37-4569-9C30-95678D619DC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54CD8-D8EF-46AA-9D8B-8363D6BAE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238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81817-5A37-4569-9C30-95678D619DC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54CD8-D8EF-46AA-9D8B-8363D6BAE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631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81817-5A37-4569-9C30-95678D619DC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54CD8-D8EF-46AA-9D8B-8363D6BAE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622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81817-5A37-4569-9C30-95678D619DC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54CD8-D8EF-46AA-9D8B-8363D6BAE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328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81817-5A37-4569-9C30-95678D619DC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54CD8-D8EF-46AA-9D8B-8363D6BAE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891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81817-5A37-4569-9C30-95678D619DC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54CD8-D8EF-46AA-9D8B-8363D6BAE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492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81817-5A37-4569-9C30-95678D619DC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54CD8-D8EF-46AA-9D8B-8363D6BAE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43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81817-5A37-4569-9C30-95678D619DC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54CD8-D8EF-46AA-9D8B-8363D6BAE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862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81817-5A37-4569-9C30-95678D619DC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54CD8-D8EF-46AA-9D8B-8363D6BAE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919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D81817-5A37-4569-9C30-95678D619DC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854CD8-D8EF-46AA-9D8B-8363D6BAE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737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09"/>
          <a:stretch/>
        </p:blipFill>
        <p:spPr>
          <a:xfrm>
            <a:off x="2696551" y="2094807"/>
            <a:ext cx="2048180" cy="265102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41"/>
          <a:stretch/>
        </p:blipFill>
        <p:spPr>
          <a:xfrm>
            <a:off x="4839559" y="2090057"/>
            <a:ext cx="1887000" cy="265778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171254" y="1696624"/>
            <a:ext cx="541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T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769838" y="1696624"/>
            <a:ext cx="680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TS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241884" y="1696624"/>
            <a:ext cx="541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T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789704" y="1696624"/>
            <a:ext cx="680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TS1</a:t>
            </a:r>
          </a:p>
        </p:txBody>
      </p:sp>
      <p:cxnSp>
        <p:nvCxnSpPr>
          <p:cNvPr id="12" name="Straight Connector 11"/>
          <p:cNvCxnSpPr/>
          <p:nvPr/>
        </p:nvCxnSpPr>
        <p:spPr>
          <a:xfrm>
            <a:off x="4640385" y="3116424"/>
            <a:ext cx="28294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4640385" y="3698032"/>
            <a:ext cx="28294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4520792" y="2825620"/>
            <a:ext cx="6624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kD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520792" y="3424201"/>
            <a:ext cx="6624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kDa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6629496" y="3355910"/>
            <a:ext cx="28294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6912445" y="3217410"/>
            <a:ext cx="17899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-actin (42kDa)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2555076" y="3217410"/>
            <a:ext cx="28294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643730" y="3071233"/>
            <a:ext cx="967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ts1 (52kDa)</a:t>
            </a: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33909" y="-436888"/>
            <a:ext cx="7065876" cy="3084843"/>
          </a:xfrm>
          <a:prstGeom prst="rect">
            <a:avLst/>
          </a:prstGeom>
        </p:spPr>
      </p:pic>
      <p:grpSp>
        <p:nvGrpSpPr>
          <p:cNvPr id="19" name="Group 18">
            <a:extLst>
              <a:ext uri="{FF2B5EF4-FFF2-40B4-BE49-F238E27FC236}">
                <a16:creationId xmlns:a16="http://schemas.microsoft.com/office/drawing/2014/main" id="{59DD4C31-FA71-4381-AE79-A51BC1B0A25B}"/>
              </a:ext>
            </a:extLst>
          </p:cNvPr>
          <p:cNvGrpSpPr>
            <a:grpSpLocks noChangeAspect="1"/>
          </p:cNvGrpSpPr>
          <p:nvPr/>
        </p:nvGrpSpPr>
        <p:grpSpPr>
          <a:xfrm>
            <a:off x="7636269" y="4745836"/>
            <a:ext cx="3961922" cy="2042025"/>
            <a:chOff x="747596" y="3589261"/>
            <a:chExt cx="5753743" cy="2965550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D6AF8572-25CC-43CF-9DE1-36D26751FF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609"/>
            <a:stretch/>
          </p:blipFill>
          <p:spPr>
            <a:xfrm>
              <a:off x="1409695" y="3901772"/>
              <a:ext cx="2048180" cy="2651029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EE26C48A-0F93-400B-9ADF-DBE90BC772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41"/>
            <a:stretch/>
          </p:blipFill>
          <p:spPr>
            <a:xfrm>
              <a:off x="3552703" y="3897022"/>
              <a:ext cx="1887000" cy="2657789"/>
            </a:xfrm>
            <a:prstGeom prst="rect">
              <a:avLst/>
            </a:prstGeom>
          </p:spPr>
        </p:pic>
        <p:sp>
          <p:nvSpPr>
            <p:cNvPr id="25" name="TextBox 5">
              <a:extLst>
                <a:ext uri="{FF2B5EF4-FFF2-40B4-BE49-F238E27FC236}">
                  <a16:creationId xmlns:a16="http://schemas.microsoft.com/office/drawing/2014/main" id="{0B32EA8C-078B-491D-9CB7-F090B6A19110}"/>
                </a:ext>
              </a:extLst>
            </p:cNvPr>
            <p:cNvSpPr txBox="1"/>
            <p:nvPr/>
          </p:nvSpPr>
          <p:spPr>
            <a:xfrm>
              <a:off x="1884398" y="3589261"/>
              <a:ext cx="541175" cy="3352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b="1" dirty="0"/>
                <a:t>NT</a:t>
              </a:r>
            </a:p>
          </p:txBody>
        </p:sp>
        <p:sp>
          <p:nvSpPr>
            <p:cNvPr id="26" name="TextBox 6">
              <a:extLst>
                <a:ext uri="{FF2B5EF4-FFF2-40B4-BE49-F238E27FC236}">
                  <a16:creationId xmlns:a16="http://schemas.microsoft.com/office/drawing/2014/main" id="{59030D42-8117-4AD2-8A73-FBE477C1CBF2}"/>
                </a:ext>
              </a:extLst>
            </p:cNvPr>
            <p:cNvSpPr txBox="1"/>
            <p:nvPr/>
          </p:nvSpPr>
          <p:spPr>
            <a:xfrm>
              <a:off x="2482980" y="3589261"/>
              <a:ext cx="870547" cy="3352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b="1" dirty="0"/>
                <a:t>ETS1 KO</a:t>
              </a:r>
            </a:p>
          </p:txBody>
        </p:sp>
        <p:sp>
          <p:nvSpPr>
            <p:cNvPr id="27" name="TextBox 7">
              <a:extLst>
                <a:ext uri="{FF2B5EF4-FFF2-40B4-BE49-F238E27FC236}">
                  <a16:creationId xmlns:a16="http://schemas.microsoft.com/office/drawing/2014/main" id="{3FC41525-C885-4096-A26B-05E7E8C6538A}"/>
                </a:ext>
              </a:extLst>
            </p:cNvPr>
            <p:cNvSpPr txBox="1"/>
            <p:nvPr/>
          </p:nvSpPr>
          <p:spPr>
            <a:xfrm>
              <a:off x="3955028" y="3589261"/>
              <a:ext cx="541175" cy="3352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b="1" dirty="0"/>
                <a:t>NT</a:t>
              </a:r>
            </a:p>
          </p:txBody>
        </p:sp>
        <p:sp>
          <p:nvSpPr>
            <p:cNvPr id="28" name="TextBox 8">
              <a:extLst>
                <a:ext uri="{FF2B5EF4-FFF2-40B4-BE49-F238E27FC236}">
                  <a16:creationId xmlns:a16="http://schemas.microsoft.com/office/drawing/2014/main" id="{3DC8DB4C-23B7-4DCB-9855-52D3A87BAE10}"/>
                </a:ext>
              </a:extLst>
            </p:cNvPr>
            <p:cNvSpPr txBox="1"/>
            <p:nvPr/>
          </p:nvSpPr>
          <p:spPr>
            <a:xfrm>
              <a:off x="4502848" y="3589261"/>
              <a:ext cx="839793" cy="3352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b="1" dirty="0"/>
                <a:t>ETS1 KO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075E1633-B4FB-4178-95DE-576EC1843F0B}"/>
                </a:ext>
              </a:extLst>
            </p:cNvPr>
            <p:cNvCxnSpPr/>
            <p:nvPr/>
          </p:nvCxnSpPr>
          <p:spPr>
            <a:xfrm>
              <a:off x="3353529" y="4923389"/>
              <a:ext cx="28294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DB8C31E9-9B59-46C2-B37C-0C78BE559546}"/>
                </a:ext>
              </a:extLst>
            </p:cNvPr>
            <p:cNvCxnSpPr/>
            <p:nvPr/>
          </p:nvCxnSpPr>
          <p:spPr>
            <a:xfrm>
              <a:off x="3353529" y="5504997"/>
              <a:ext cx="28294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TextBox 13">
              <a:extLst>
                <a:ext uri="{FF2B5EF4-FFF2-40B4-BE49-F238E27FC236}">
                  <a16:creationId xmlns:a16="http://schemas.microsoft.com/office/drawing/2014/main" id="{24E0C379-51C0-4D26-A9D0-0503543CDAC5}"/>
                </a:ext>
              </a:extLst>
            </p:cNvPr>
            <p:cNvSpPr txBox="1"/>
            <p:nvPr/>
          </p:nvSpPr>
          <p:spPr>
            <a:xfrm>
              <a:off x="3212518" y="4696838"/>
              <a:ext cx="662473" cy="2905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700" dirty="0"/>
                <a:t>55kDa</a:t>
              </a:r>
            </a:p>
          </p:txBody>
        </p:sp>
        <p:sp>
          <p:nvSpPr>
            <p:cNvPr id="32" name="TextBox 14">
              <a:extLst>
                <a:ext uri="{FF2B5EF4-FFF2-40B4-BE49-F238E27FC236}">
                  <a16:creationId xmlns:a16="http://schemas.microsoft.com/office/drawing/2014/main" id="{F938ACBE-88E2-4168-8B44-F935E436141F}"/>
                </a:ext>
              </a:extLst>
            </p:cNvPr>
            <p:cNvSpPr txBox="1"/>
            <p:nvPr/>
          </p:nvSpPr>
          <p:spPr>
            <a:xfrm>
              <a:off x="3212518" y="5231167"/>
              <a:ext cx="662473" cy="2905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700" dirty="0"/>
                <a:t>35kDa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6A73A52C-30EC-4B58-85E1-7AAB5BF60821}"/>
                </a:ext>
              </a:extLst>
            </p:cNvPr>
            <p:cNvCxnSpPr/>
            <p:nvPr/>
          </p:nvCxnSpPr>
          <p:spPr>
            <a:xfrm>
              <a:off x="5278386" y="5162876"/>
              <a:ext cx="2829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TextBox 16">
              <a:extLst>
                <a:ext uri="{FF2B5EF4-FFF2-40B4-BE49-F238E27FC236}">
                  <a16:creationId xmlns:a16="http://schemas.microsoft.com/office/drawing/2014/main" id="{D2253587-A871-4808-A3B9-ACEC8A3DCAEA}"/>
                </a:ext>
              </a:extLst>
            </p:cNvPr>
            <p:cNvSpPr txBox="1"/>
            <p:nvPr/>
          </p:nvSpPr>
          <p:spPr>
            <a:xfrm>
              <a:off x="5473224" y="4981295"/>
              <a:ext cx="1028115" cy="4916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/>
                <a:t>B-actin (42kDa)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C33B1BF4-A51E-49F2-A169-7542304E44BC}"/>
                </a:ext>
              </a:extLst>
            </p:cNvPr>
            <p:cNvCxnSpPr/>
            <p:nvPr/>
          </p:nvCxnSpPr>
          <p:spPr>
            <a:xfrm>
              <a:off x="1278929" y="5024375"/>
              <a:ext cx="2829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TextBox 20">
              <a:extLst>
                <a:ext uri="{FF2B5EF4-FFF2-40B4-BE49-F238E27FC236}">
                  <a16:creationId xmlns:a16="http://schemas.microsoft.com/office/drawing/2014/main" id="{629F7DE0-A7EA-4CBF-80F1-9346D1D70CDD}"/>
                </a:ext>
              </a:extLst>
            </p:cNvPr>
            <p:cNvSpPr txBox="1"/>
            <p:nvPr/>
          </p:nvSpPr>
          <p:spPr>
            <a:xfrm>
              <a:off x="747596" y="4877997"/>
              <a:ext cx="781444" cy="4916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/>
                <a:t>Ets1 (52kDa)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E6F4DEBD-3F4B-44CC-BEC1-BED271968CDD}"/>
              </a:ext>
            </a:extLst>
          </p:cNvPr>
          <p:cNvSpPr txBox="1"/>
          <p:nvPr/>
        </p:nvSpPr>
        <p:spPr>
          <a:xfrm>
            <a:off x="8682000" y="4393296"/>
            <a:ext cx="1886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Areks</a:t>
            </a:r>
            <a:r>
              <a:rPr lang="en-US" dirty="0"/>
              <a:t> thesis final</a:t>
            </a:r>
          </a:p>
        </p:txBody>
      </p:sp>
    </p:spTree>
    <p:extLst>
      <p:ext uri="{BB962C8B-B14F-4D97-AF65-F5344CB8AC3E}">
        <p14:creationId xmlns:p14="http://schemas.microsoft.com/office/powerpoint/2010/main" val="1804853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Leibniz-Rechenzentru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dirli, Arek</dc:creator>
  <cp:lastModifiedBy>Arek Kendirli</cp:lastModifiedBy>
  <cp:revision>6</cp:revision>
  <dcterms:created xsi:type="dcterms:W3CDTF">2021-12-11T18:18:26Z</dcterms:created>
  <dcterms:modified xsi:type="dcterms:W3CDTF">2022-03-01T10:21:00Z</dcterms:modified>
</cp:coreProperties>
</file>